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AE7F6"/>
    <a:srgbClr val="EAF0FA"/>
    <a:srgbClr val="E4ECF8"/>
    <a:srgbClr val="EFF4FB"/>
    <a:srgbClr val="0000FF"/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16" autoAdjust="0"/>
    <p:restoredTop sz="94660"/>
  </p:normalViewPr>
  <p:slideViewPr>
    <p:cSldViewPr snapToGrid="0">
      <p:cViewPr>
        <p:scale>
          <a:sx n="100" d="100"/>
          <a:sy n="100" d="100"/>
        </p:scale>
        <p:origin x="-2064" y="-72"/>
      </p:cViewPr>
      <p:guideLst>
        <p:guide orient="horz" pos="5111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69EE2-1DE0-4E17-9A01-43CBB71470D7}" type="datetimeFigureOut">
              <a:rPr lang="en-US" smtClean="0"/>
              <a:t>2/28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02900-22C8-4FCC-86D8-68A06DC9F70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81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69EE2-1DE0-4E17-9A01-43CBB71470D7}" type="datetimeFigureOut">
              <a:rPr lang="en-US" smtClean="0"/>
              <a:t>2/28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02900-22C8-4FCC-86D8-68A06DC9F70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74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69EE2-1DE0-4E17-9A01-43CBB71470D7}" type="datetimeFigureOut">
              <a:rPr lang="en-US" smtClean="0"/>
              <a:t>2/28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02900-22C8-4FCC-86D8-68A06DC9F70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733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69EE2-1DE0-4E17-9A01-43CBB71470D7}" type="datetimeFigureOut">
              <a:rPr lang="en-US" smtClean="0"/>
              <a:t>2/28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02900-22C8-4FCC-86D8-68A06DC9F70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791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69EE2-1DE0-4E17-9A01-43CBB71470D7}" type="datetimeFigureOut">
              <a:rPr lang="en-US" smtClean="0"/>
              <a:t>2/28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02900-22C8-4FCC-86D8-68A06DC9F70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18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69EE2-1DE0-4E17-9A01-43CBB71470D7}" type="datetimeFigureOut">
              <a:rPr lang="en-US" smtClean="0"/>
              <a:t>2/28/2022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02900-22C8-4FCC-86D8-68A06DC9F70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403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69EE2-1DE0-4E17-9A01-43CBB71470D7}" type="datetimeFigureOut">
              <a:rPr lang="en-US" smtClean="0"/>
              <a:t>2/28/2022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02900-22C8-4FCC-86D8-68A06DC9F70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627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69EE2-1DE0-4E17-9A01-43CBB71470D7}" type="datetimeFigureOut">
              <a:rPr lang="en-US" smtClean="0"/>
              <a:t>2/28/2022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02900-22C8-4FCC-86D8-68A06DC9F70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448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69EE2-1DE0-4E17-9A01-43CBB71470D7}" type="datetimeFigureOut">
              <a:rPr lang="en-US" smtClean="0"/>
              <a:t>2/28/2022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02900-22C8-4FCC-86D8-68A06DC9F70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050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69EE2-1DE0-4E17-9A01-43CBB71470D7}" type="datetimeFigureOut">
              <a:rPr lang="en-US" smtClean="0"/>
              <a:t>2/28/2022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02900-22C8-4FCC-86D8-68A06DC9F70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627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69EE2-1DE0-4E17-9A01-43CBB71470D7}" type="datetimeFigureOut">
              <a:rPr lang="en-US" smtClean="0"/>
              <a:t>2/28/2022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02900-22C8-4FCC-86D8-68A06DC9F70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597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A69EE2-1DE0-4E17-9A01-43CBB71470D7}" type="datetimeFigureOut">
              <a:rPr lang="en-US" smtClean="0"/>
              <a:t>2/28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402900-22C8-4FCC-86D8-68A06DC9F70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6841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3" name="Gruppieren 92"/>
          <p:cNvGrpSpPr/>
          <p:nvPr/>
        </p:nvGrpSpPr>
        <p:grpSpPr>
          <a:xfrm>
            <a:off x="-47703" y="100994"/>
            <a:ext cx="6970565" cy="7475074"/>
            <a:chOff x="-47703" y="100994"/>
            <a:chExt cx="6970565" cy="7475074"/>
          </a:xfrm>
        </p:grpSpPr>
        <p:grpSp>
          <p:nvGrpSpPr>
            <p:cNvPr id="92" name="Gruppieren 91"/>
            <p:cNvGrpSpPr/>
            <p:nvPr/>
          </p:nvGrpSpPr>
          <p:grpSpPr>
            <a:xfrm>
              <a:off x="316819" y="100994"/>
              <a:ext cx="5567819" cy="3256577"/>
              <a:chOff x="316819" y="100994"/>
              <a:chExt cx="5567819" cy="3256577"/>
            </a:xfrm>
          </p:grpSpPr>
          <p:sp>
            <p:nvSpPr>
              <p:cNvPr id="165" name="Textfeld 164"/>
              <p:cNvSpPr txBox="1"/>
              <p:nvPr/>
            </p:nvSpPr>
            <p:spPr>
              <a:xfrm>
                <a:off x="3212419" y="100994"/>
                <a:ext cx="415498" cy="5847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3200" b="1" dirty="0" smtClean="0"/>
                  <a:t>B</a:t>
                </a:r>
                <a:endParaRPr lang="en-US" sz="3200" b="1" dirty="0"/>
              </a:p>
            </p:txBody>
          </p:sp>
          <p:grpSp>
            <p:nvGrpSpPr>
              <p:cNvPr id="60" name="Gruppieren 59"/>
              <p:cNvGrpSpPr/>
              <p:nvPr/>
            </p:nvGrpSpPr>
            <p:grpSpPr>
              <a:xfrm>
                <a:off x="316819" y="100994"/>
                <a:ext cx="2572207" cy="3222163"/>
                <a:chOff x="2494" y="100994"/>
                <a:chExt cx="2572207" cy="3222163"/>
              </a:xfrm>
            </p:grpSpPr>
            <p:sp>
              <p:nvSpPr>
                <p:cNvPr id="134" name="Textfeld 133"/>
                <p:cNvSpPr txBox="1"/>
                <p:nvPr/>
              </p:nvSpPr>
              <p:spPr>
                <a:xfrm>
                  <a:off x="2494" y="100994"/>
                  <a:ext cx="433132" cy="58477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3200" b="1" dirty="0" smtClean="0"/>
                    <a:t>A</a:t>
                  </a:r>
                  <a:endParaRPr lang="en-US" sz="3200" b="1" dirty="0"/>
                </a:p>
              </p:txBody>
            </p:sp>
            <p:pic>
              <p:nvPicPr>
                <p:cNvPr id="125" name="Picture 3" descr="N:\dept\AG-Roseobacter\Vicky\Gelelektrophorese\2021\10 Oktober\2021-10-28_Replikationssysteme RV und PCR_3.png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742" t="49449" r="54035" b="31301"/>
                <a:stretch/>
              </p:blipFill>
              <p:spPr bwMode="auto">
                <a:xfrm>
                  <a:off x="628650" y="933451"/>
                  <a:ext cx="1295400" cy="1447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26" name="Picture 3" descr="N:\dept\AG-Roseobacter\Vicky\Gelelektrophorese\2021\10 Oktober\2021-10-28_Replikationssysteme RV und PCR_3.png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742" t="20195" r="54035" b="73473"/>
                <a:stretch/>
              </p:blipFill>
              <p:spPr bwMode="auto">
                <a:xfrm>
                  <a:off x="638175" y="2833696"/>
                  <a:ext cx="1295400" cy="476251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grpSp>
              <p:nvGrpSpPr>
                <p:cNvPr id="12" name="Gruppieren 11"/>
                <p:cNvGrpSpPr/>
                <p:nvPr/>
              </p:nvGrpSpPr>
              <p:grpSpPr>
                <a:xfrm>
                  <a:off x="795665" y="215898"/>
                  <a:ext cx="984565" cy="680740"/>
                  <a:chOff x="938540" y="215898"/>
                  <a:chExt cx="984565" cy="680740"/>
                </a:xfrm>
              </p:grpSpPr>
              <p:sp>
                <p:nvSpPr>
                  <p:cNvPr id="131" name="Textfeld 130"/>
                  <p:cNvSpPr txBox="1"/>
                  <p:nvPr/>
                </p:nvSpPr>
                <p:spPr>
                  <a:xfrm>
                    <a:off x="1134619" y="215898"/>
                    <a:ext cx="592406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de-DE" sz="1400" b="1" dirty="0" err="1" smtClean="0"/>
                      <a:t>RepQ</a:t>
                    </a:r>
                    <a:endParaRPr lang="de-DE" sz="1400" b="1" dirty="0" smtClean="0"/>
                  </a:p>
                </p:txBody>
              </p:sp>
              <p:sp>
                <p:nvSpPr>
                  <p:cNvPr id="139" name="Textfeld 138"/>
                  <p:cNvSpPr txBox="1"/>
                  <p:nvPr/>
                </p:nvSpPr>
                <p:spPr>
                  <a:xfrm>
                    <a:off x="938540" y="434973"/>
                    <a:ext cx="984565" cy="4616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de-DE" sz="1200" i="1" dirty="0" smtClean="0"/>
                      <a:t>S. </a:t>
                    </a:r>
                    <a:r>
                      <a:rPr lang="de-DE" sz="1200" i="1" dirty="0" err="1" smtClean="0"/>
                      <a:t>indolifex</a:t>
                    </a:r>
                    <a:endParaRPr lang="de-DE" sz="1200" i="1" dirty="0"/>
                  </a:p>
                  <a:p>
                    <a:pPr algn="ctr"/>
                    <a:r>
                      <a:rPr lang="de-DE" sz="1200" dirty="0" smtClean="0"/>
                      <a:t>DSM </a:t>
                    </a:r>
                    <a:r>
                      <a:rPr lang="de-DE" sz="1200" dirty="0" smtClean="0"/>
                      <a:t>14862</a:t>
                    </a:r>
                    <a:r>
                      <a:rPr lang="de-DE" sz="1200" baseline="30000" dirty="0" smtClean="0"/>
                      <a:t>T</a:t>
                    </a:r>
                    <a:endParaRPr lang="de-DE" sz="1200" baseline="30000" dirty="0" smtClean="0"/>
                  </a:p>
                </p:txBody>
              </p:sp>
            </p:grpSp>
            <p:cxnSp>
              <p:nvCxnSpPr>
                <p:cNvPr id="178" name="Gerade Verbindung 177"/>
                <p:cNvCxnSpPr/>
                <p:nvPr/>
              </p:nvCxnSpPr>
              <p:spPr>
                <a:xfrm>
                  <a:off x="1934683" y="159424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9" name="Gerade Verbindung 178"/>
                <p:cNvCxnSpPr/>
                <p:nvPr/>
              </p:nvCxnSpPr>
              <p:spPr>
                <a:xfrm>
                  <a:off x="1934683" y="1375366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0" name="Gerade Verbindung 179"/>
                <p:cNvCxnSpPr/>
                <p:nvPr/>
              </p:nvCxnSpPr>
              <p:spPr>
                <a:xfrm>
                  <a:off x="1939446" y="1836929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1" name="Textfeld 180"/>
                <p:cNvSpPr txBox="1"/>
                <p:nvPr/>
              </p:nvSpPr>
              <p:spPr>
                <a:xfrm>
                  <a:off x="1989469" y="1265250"/>
                  <a:ext cx="56618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b="1" dirty="0" smtClean="0"/>
                    <a:t>4000 </a:t>
                  </a:r>
                  <a:r>
                    <a:rPr lang="de-DE" sz="900" b="1" dirty="0" err="1" smtClean="0"/>
                    <a:t>bp</a:t>
                  </a:r>
                  <a:endParaRPr lang="de-DE" sz="900" b="1" dirty="0"/>
                </a:p>
              </p:txBody>
            </p:sp>
            <p:sp>
              <p:nvSpPr>
                <p:cNvPr id="182" name="Textfeld 181"/>
                <p:cNvSpPr txBox="1"/>
                <p:nvPr/>
              </p:nvSpPr>
              <p:spPr>
                <a:xfrm>
                  <a:off x="1989469" y="1482634"/>
                  <a:ext cx="56618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b="1" dirty="0" smtClean="0"/>
                    <a:t>2000 </a:t>
                  </a:r>
                  <a:r>
                    <a:rPr lang="de-DE" sz="900" b="1" dirty="0" err="1" smtClean="0"/>
                    <a:t>bp</a:t>
                  </a:r>
                  <a:endParaRPr lang="de-DE" sz="900" b="1" dirty="0"/>
                </a:p>
              </p:txBody>
            </p:sp>
            <p:sp>
              <p:nvSpPr>
                <p:cNvPr id="183" name="Textfeld 182"/>
                <p:cNvSpPr txBox="1"/>
                <p:nvPr/>
              </p:nvSpPr>
              <p:spPr>
                <a:xfrm>
                  <a:off x="1989469" y="1728467"/>
                  <a:ext cx="56618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b="1" dirty="0" smtClean="0"/>
                    <a:t>1000 </a:t>
                  </a:r>
                  <a:r>
                    <a:rPr lang="de-DE" sz="900" b="1" dirty="0" err="1" smtClean="0"/>
                    <a:t>bp</a:t>
                  </a:r>
                  <a:endParaRPr lang="de-DE" sz="900" b="1" dirty="0"/>
                </a:p>
              </p:txBody>
            </p:sp>
            <p:sp>
              <p:nvSpPr>
                <p:cNvPr id="184" name="Textfeld 183"/>
                <p:cNvSpPr txBox="1"/>
                <p:nvPr/>
              </p:nvSpPr>
              <p:spPr>
                <a:xfrm>
                  <a:off x="2008520" y="3092325"/>
                  <a:ext cx="56618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b="1" dirty="0" smtClean="0"/>
                    <a:t>2000 </a:t>
                  </a:r>
                  <a:r>
                    <a:rPr lang="de-DE" sz="900" b="1" dirty="0" err="1" smtClean="0"/>
                    <a:t>bp</a:t>
                  </a:r>
                  <a:endParaRPr lang="de-DE" sz="900" b="1" dirty="0"/>
                </a:p>
              </p:txBody>
            </p:sp>
            <p:sp>
              <p:nvSpPr>
                <p:cNvPr id="185" name="Textfeld 184"/>
                <p:cNvSpPr txBox="1"/>
                <p:nvPr/>
              </p:nvSpPr>
              <p:spPr>
                <a:xfrm>
                  <a:off x="2008520" y="2828556"/>
                  <a:ext cx="56618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b="1" dirty="0" smtClean="0"/>
                    <a:t>3000 </a:t>
                  </a:r>
                  <a:r>
                    <a:rPr lang="de-DE" sz="900" b="1" dirty="0" err="1" smtClean="0"/>
                    <a:t>bp</a:t>
                  </a:r>
                  <a:endParaRPr lang="de-DE" sz="900" b="1" dirty="0"/>
                </a:p>
              </p:txBody>
            </p:sp>
            <p:cxnSp>
              <p:nvCxnSpPr>
                <p:cNvPr id="186" name="Gerade Verbindung 185"/>
                <p:cNvCxnSpPr/>
                <p:nvPr/>
              </p:nvCxnSpPr>
              <p:spPr>
                <a:xfrm flipV="1">
                  <a:off x="1947388" y="2943199"/>
                  <a:ext cx="103663" cy="51175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7" name="Gerade Verbindung 186"/>
                <p:cNvCxnSpPr/>
                <p:nvPr/>
              </p:nvCxnSpPr>
              <p:spPr>
                <a:xfrm>
                  <a:off x="1947388" y="3146581"/>
                  <a:ext cx="103663" cy="6332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8" name="Rechteck 187"/>
                <p:cNvSpPr/>
                <p:nvPr/>
              </p:nvSpPr>
              <p:spPr>
                <a:xfrm>
                  <a:off x="95171" y="894651"/>
                  <a:ext cx="53309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 fontAlgn="ctr"/>
                  <a:r>
                    <a:rPr lang="de-DE" sz="1200" b="1" dirty="0" err="1" smtClean="0"/>
                    <a:t>EcoRI</a:t>
                  </a:r>
                  <a:endParaRPr lang="en-US" sz="1200" b="1" i="1" dirty="0">
                    <a:solidFill>
                      <a:srgbClr val="000000"/>
                    </a:solidFill>
                  </a:endParaRPr>
                </a:p>
              </p:txBody>
            </p:sp>
            <p:sp>
              <p:nvSpPr>
                <p:cNvPr id="189" name="Rechteck 188"/>
                <p:cNvSpPr/>
                <p:nvPr/>
              </p:nvSpPr>
              <p:spPr>
                <a:xfrm>
                  <a:off x="197342" y="2556773"/>
                  <a:ext cx="43473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ctr"/>
                  <a:r>
                    <a:rPr lang="de-DE" sz="1200" b="1" dirty="0" smtClean="0"/>
                    <a:t>PCR</a:t>
                  </a:r>
                  <a:endParaRPr lang="en-US" sz="1200" b="1" i="1" dirty="0">
                    <a:solidFill>
                      <a:srgbClr val="000000"/>
                    </a:solidFill>
                  </a:endParaRPr>
                </a:p>
              </p:txBody>
            </p:sp>
            <p:grpSp>
              <p:nvGrpSpPr>
                <p:cNvPr id="37" name="Gruppieren 36"/>
                <p:cNvGrpSpPr/>
                <p:nvPr/>
              </p:nvGrpSpPr>
              <p:grpSpPr>
                <a:xfrm>
                  <a:off x="595797" y="2556773"/>
                  <a:ext cx="1371831" cy="276999"/>
                  <a:chOff x="595797" y="2556773"/>
                  <a:chExt cx="1371831" cy="276999"/>
                </a:xfrm>
              </p:grpSpPr>
              <p:grpSp>
                <p:nvGrpSpPr>
                  <p:cNvPr id="151" name="Gruppieren 150"/>
                  <p:cNvGrpSpPr/>
                  <p:nvPr/>
                </p:nvGrpSpPr>
                <p:grpSpPr>
                  <a:xfrm>
                    <a:off x="878378" y="2556773"/>
                    <a:ext cx="804939" cy="276999"/>
                    <a:chOff x="745028" y="5012628"/>
                    <a:chExt cx="804939" cy="276999"/>
                  </a:xfrm>
                </p:grpSpPr>
                <p:sp>
                  <p:nvSpPr>
                    <p:cNvPr id="152" name="Rechteck 151"/>
                    <p:cNvSpPr/>
                    <p:nvPr/>
                  </p:nvSpPr>
                  <p:spPr>
                    <a:xfrm>
                      <a:off x="1286753" y="5012628"/>
                      <a:ext cx="263214" cy="249840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ctr"/>
                      <a:r>
                        <a:rPr lang="en-US" sz="1200" b="1" u="none" strike="noStrike" dirty="0" smtClean="0">
                          <a:effectLst/>
                        </a:rPr>
                        <a:t>3</a:t>
                      </a:r>
                      <a:endParaRPr lang="en-US" sz="1200" b="1" i="1" dirty="0">
                        <a:solidFill>
                          <a:srgbClr val="000000"/>
                        </a:solidFill>
                      </a:endParaRPr>
                    </a:p>
                  </p:txBody>
                </p:sp>
                <p:sp>
                  <p:nvSpPr>
                    <p:cNvPr id="153" name="Rechteck 152"/>
                    <p:cNvSpPr/>
                    <p:nvPr/>
                  </p:nvSpPr>
                  <p:spPr>
                    <a:xfrm>
                      <a:off x="745028" y="5012628"/>
                      <a:ext cx="263214" cy="249840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ctr"/>
                      <a:r>
                        <a:rPr lang="de-DE" sz="1200" b="1" dirty="0"/>
                        <a:t>1</a:t>
                      </a:r>
                      <a:endParaRPr lang="en-US" sz="1200" b="1" i="1" dirty="0">
                        <a:solidFill>
                          <a:srgbClr val="000000"/>
                        </a:solidFill>
                      </a:endParaRPr>
                    </a:p>
                  </p:txBody>
                </p:sp>
                <p:sp>
                  <p:nvSpPr>
                    <p:cNvPr id="154" name="Rechteck 153"/>
                    <p:cNvSpPr/>
                    <p:nvPr/>
                  </p:nvSpPr>
                  <p:spPr>
                    <a:xfrm>
                      <a:off x="1015890" y="5012628"/>
                      <a:ext cx="263214" cy="276999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ctr"/>
                      <a:r>
                        <a:rPr lang="de-DE" sz="1200" b="1" dirty="0">
                          <a:solidFill>
                            <a:srgbClr val="FF0000"/>
                          </a:solidFill>
                        </a:rPr>
                        <a:t>2</a:t>
                      </a:r>
                      <a:endParaRPr lang="en-US" sz="1200" b="1" dirty="0">
                        <a:solidFill>
                          <a:srgbClr val="FF0000"/>
                        </a:solidFill>
                      </a:endParaRPr>
                    </a:p>
                  </p:txBody>
                </p:sp>
              </p:grpSp>
              <p:sp>
                <p:nvSpPr>
                  <p:cNvPr id="202" name="Rechteck 201"/>
                  <p:cNvSpPr/>
                  <p:nvPr/>
                </p:nvSpPr>
                <p:spPr>
                  <a:xfrm>
                    <a:off x="595797" y="2556773"/>
                    <a:ext cx="31931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 smtClean="0"/>
                      <a:t>M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03" name="Rechteck 202"/>
                  <p:cNvSpPr/>
                  <p:nvPr/>
                </p:nvSpPr>
                <p:spPr>
                  <a:xfrm>
                    <a:off x="1648310" y="2556773"/>
                    <a:ext cx="31931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 smtClean="0"/>
                      <a:t>M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</p:grpSp>
            <p:grpSp>
              <p:nvGrpSpPr>
                <p:cNvPr id="36" name="Gruppieren 35"/>
                <p:cNvGrpSpPr/>
                <p:nvPr/>
              </p:nvGrpSpPr>
              <p:grpSpPr>
                <a:xfrm>
                  <a:off x="614845" y="894651"/>
                  <a:ext cx="1371831" cy="276999"/>
                  <a:chOff x="614845" y="894651"/>
                  <a:chExt cx="1371831" cy="276999"/>
                </a:xfrm>
              </p:grpSpPr>
              <p:grpSp>
                <p:nvGrpSpPr>
                  <p:cNvPr id="140" name="Gruppieren 139"/>
                  <p:cNvGrpSpPr/>
                  <p:nvPr/>
                </p:nvGrpSpPr>
                <p:grpSpPr>
                  <a:xfrm>
                    <a:off x="887903" y="894651"/>
                    <a:ext cx="804939" cy="276999"/>
                    <a:chOff x="745028" y="5012628"/>
                    <a:chExt cx="804939" cy="276999"/>
                  </a:xfrm>
                </p:grpSpPr>
                <p:sp>
                  <p:nvSpPr>
                    <p:cNvPr id="147" name="Rechteck 146"/>
                    <p:cNvSpPr/>
                    <p:nvPr/>
                  </p:nvSpPr>
                  <p:spPr>
                    <a:xfrm>
                      <a:off x="1286753" y="5012628"/>
                      <a:ext cx="263214" cy="249840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ctr"/>
                      <a:r>
                        <a:rPr lang="en-US" sz="1200" b="1" u="none" strike="noStrike" dirty="0" smtClean="0">
                          <a:effectLst/>
                        </a:rPr>
                        <a:t>3</a:t>
                      </a:r>
                      <a:endParaRPr lang="en-US" sz="1200" b="1" i="1" dirty="0">
                        <a:solidFill>
                          <a:srgbClr val="000000"/>
                        </a:solidFill>
                      </a:endParaRPr>
                    </a:p>
                  </p:txBody>
                </p:sp>
                <p:sp>
                  <p:nvSpPr>
                    <p:cNvPr id="148" name="Rechteck 147"/>
                    <p:cNvSpPr/>
                    <p:nvPr/>
                  </p:nvSpPr>
                  <p:spPr>
                    <a:xfrm>
                      <a:off x="745028" y="5012628"/>
                      <a:ext cx="263214" cy="249840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ctr"/>
                      <a:r>
                        <a:rPr lang="de-DE" sz="1200" b="1" dirty="0"/>
                        <a:t>1</a:t>
                      </a:r>
                      <a:endParaRPr lang="en-US" sz="1200" b="1" i="1" dirty="0">
                        <a:solidFill>
                          <a:srgbClr val="000000"/>
                        </a:solidFill>
                      </a:endParaRPr>
                    </a:p>
                  </p:txBody>
                </p:sp>
                <p:sp>
                  <p:nvSpPr>
                    <p:cNvPr id="149" name="Rechteck 148"/>
                    <p:cNvSpPr/>
                    <p:nvPr/>
                  </p:nvSpPr>
                  <p:spPr>
                    <a:xfrm>
                      <a:off x="1015890" y="5012628"/>
                      <a:ext cx="263214" cy="276999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ctr"/>
                      <a:r>
                        <a:rPr lang="de-DE" sz="1200" b="1" dirty="0">
                          <a:solidFill>
                            <a:srgbClr val="FF0000"/>
                          </a:solidFill>
                        </a:rPr>
                        <a:t>2</a:t>
                      </a:r>
                      <a:endParaRPr lang="en-US" sz="1200" b="1" dirty="0">
                        <a:solidFill>
                          <a:srgbClr val="FF0000"/>
                        </a:solidFill>
                      </a:endParaRPr>
                    </a:p>
                  </p:txBody>
                </p:sp>
              </p:grpSp>
              <p:sp>
                <p:nvSpPr>
                  <p:cNvPr id="210" name="Rechteck 209"/>
                  <p:cNvSpPr/>
                  <p:nvPr/>
                </p:nvSpPr>
                <p:spPr>
                  <a:xfrm>
                    <a:off x="614845" y="894651"/>
                    <a:ext cx="31931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 smtClean="0"/>
                      <a:t>M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11" name="Rechteck 210"/>
                  <p:cNvSpPr/>
                  <p:nvPr/>
                </p:nvSpPr>
                <p:spPr>
                  <a:xfrm>
                    <a:off x="1667358" y="894651"/>
                    <a:ext cx="31931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 smtClean="0"/>
                      <a:t>M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</p:grpSp>
          </p:grpSp>
          <p:grpSp>
            <p:nvGrpSpPr>
              <p:cNvPr id="59" name="Gruppieren 58"/>
              <p:cNvGrpSpPr/>
              <p:nvPr/>
            </p:nvGrpSpPr>
            <p:grpSpPr>
              <a:xfrm>
                <a:off x="3362247" y="215898"/>
                <a:ext cx="2522391" cy="3141673"/>
                <a:chOff x="2847897" y="215898"/>
                <a:chExt cx="2522391" cy="3141673"/>
              </a:xfrm>
            </p:grpSpPr>
            <p:grpSp>
              <p:nvGrpSpPr>
                <p:cNvPr id="3" name="Gruppieren 2"/>
                <p:cNvGrpSpPr/>
                <p:nvPr/>
              </p:nvGrpSpPr>
              <p:grpSpPr>
                <a:xfrm>
                  <a:off x="3578492" y="215898"/>
                  <a:ext cx="987771" cy="680740"/>
                  <a:chOff x="4375462" y="234948"/>
                  <a:chExt cx="987771" cy="680740"/>
                </a:xfrm>
              </p:grpSpPr>
              <p:sp>
                <p:nvSpPr>
                  <p:cNvPr id="166" name="Textfeld 165"/>
                  <p:cNvSpPr txBox="1"/>
                  <p:nvPr/>
                </p:nvSpPr>
                <p:spPr>
                  <a:xfrm>
                    <a:off x="4588372" y="234948"/>
                    <a:ext cx="561949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de-DE" sz="1400" b="1" dirty="0" err="1" smtClean="0"/>
                      <a:t>RepY</a:t>
                    </a:r>
                    <a:endParaRPr lang="de-DE" sz="1400" b="1" dirty="0" smtClean="0"/>
                  </a:p>
                </p:txBody>
              </p:sp>
              <p:sp>
                <p:nvSpPr>
                  <p:cNvPr id="167" name="Textfeld 166"/>
                  <p:cNvSpPr txBox="1"/>
                  <p:nvPr/>
                </p:nvSpPr>
                <p:spPr>
                  <a:xfrm>
                    <a:off x="4375462" y="454023"/>
                    <a:ext cx="987771" cy="4616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de-DE" sz="1200" i="1" dirty="0" smtClean="0"/>
                      <a:t>S. </a:t>
                    </a:r>
                    <a:r>
                      <a:rPr lang="de-DE" sz="1200" i="1" dirty="0" err="1" smtClean="0"/>
                      <a:t>pontiacus</a:t>
                    </a:r>
                    <a:endParaRPr lang="de-DE" sz="1200" i="1" dirty="0"/>
                  </a:p>
                  <a:p>
                    <a:pPr algn="ctr"/>
                    <a:r>
                      <a:rPr lang="de-DE" sz="1200" dirty="0" smtClean="0"/>
                      <a:t>DSM 110277</a:t>
                    </a:r>
                  </a:p>
                </p:txBody>
              </p:sp>
            </p:grpSp>
            <p:pic>
              <p:nvPicPr>
                <p:cNvPr id="168" name="Picture 3" descr="N:\dept\AG-Roseobacter\Vicky\Gelelektrophorese\2021\10 Oktober\2021-10-28_Replikationssysteme RV und PCR_3.png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685" t="49251" r="67590" b="31247"/>
                <a:stretch/>
              </p:blipFill>
              <p:spPr bwMode="auto">
                <a:xfrm>
                  <a:off x="3405826" y="933451"/>
                  <a:ext cx="1333103" cy="146685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69" name="Picture 3" descr="N:\dept\AG-Roseobacter\Vicky\Gelelektrophorese\2021\10 Oktober\2021-10-28_Replikationssysteme RV und PCR_3.png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685" t="19743" r="67910" b="73292"/>
                <a:stretch/>
              </p:blipFill>
              <p:spPr bwMode="auto">
                <a:xfrm>
                  <a:off x="3405826" y="2833696"/>
                  <a:ext cx="1309049" cy="52387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90" name="Rechteck 189"/>
                <p:cNvSpPr/>
                <p:nvPr/>
              </p:nvSpPr>
              <p:spPr>
                <a:xfrm>
                  <a:off x="2847897" y="894651"/>
                  <a:ext cx="53309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 fontAlgn="ctr"/>
                  <a:r>
                    <a:rPr lang="de-DE" sz="1200" b="1" dirty="0" err="1" smtClean="0"/>
                    <a:t>EcoRI</a:t>
                  </a:r>
                  <a:endParaRPr lang="en-US" sz="1200" b="1" i="1" dirty="0">
                    <a:solidFill>
                      <a:srgbClr val="000000"/>
                    </a:solidFill>
                  </a:endParaRPr>
                </a:p>
              </p:txBody>
            </p:sp>
            <p:sp>
              <p:nvSpPr>
                <p:cNvPr id="191" name="Rechteck 190"/>
                <p:cNvSpPr/>
                <p:nvPr/>
              </p:nvSpPr>
              <p:spPr>
                <a:xfrm>
                  <a:off x="2950068" y="2556773"/>
                  <a:ext cx="43473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ctr"/>
                  <a:r>
                    <a:rPr lang="de-DE" sz="1200" b="1" dirty="0" smtClean="0"/>
                    <a:t>PCR</a:t>
                  </a:r>
                  <a:endParaRPr lang="en-US" sz="1200" b="1" i="1" dirty="0">
                    <a:solidFill>
                      <a:srgbClr val="000000"/>
                    </a:solidFill>
                  </a:endParaRPr>
                </a:p>
              </p:txBody>
            </p:sp>
            <p:cxnSp>
              <p:nvCxnSpPr>
                <p:cNvPr id="192" name="Gerade Verbindung 191"/>
                <p:cNvCxnSpPr/>
                <p:nvPr/>
              </p:nvCxnSpPr>
              <p:spPr>
                <a:xfrm>
                  <a:off x="4749320" y="1618046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3" name="Gerade Verbindung 192"/>
                <p:cNvCxnSpPr/>
                <p:nvPr/>
              </p:nvCxnSpPr>
              <p:spPr>
                <a:xfrm>
                  <a:off x="4749320" y="1394408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4" name="Gerade Verbindung 193"/>
                <p:cNvCxnSpPr/>
                <p:nvPr/>
              </p:nvCxnSpPr>
              <p:spPr>
                <a:xfrm>
                  <a:off x="4754083" y="1865497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5" name="Textfeld 194"/>
                <p:cNvSpPr txBox="1"/>
                <p:nvPr/>
              </p:nvSpPr>
              <p:spPr>
                <a:xfrm>
                  <a:off x="4804106" y="1284292"/>
                  <a:ext cx="56618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b="1" dirty="0" smtClean="0"/>
                    <a:t>4000 </a:t>
                  </a:r>
                  <a:r>
                    <a:rPr lang="de-DE" sz="900" b="1" dirty="0" err="1" smtClean="0"/>
                    <a:t>bp</a:t>
                  </a:r>
                  <a:endParaRPr lang="de-DE" sz="900" b="1" dirty="0"/>
                </a:p>
              </p:txBody>
            </p:sp>
            <p:sp>
              <p:nvSpPr>
                <p:cNvPr id="196" name="Textfeld 195"/>
                <p:cNvSpPr txBox="1"/>
                <p:nvPr/>
              </p:nvSpPr>
              <p:spPr>
                <a:xfrm>
                  <a:off x="4804106" y="1506439"/>
                  <a:ext cx="56618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b="1" dirty="0" smtClean="0"/>
                    <a:t>2000 </a:t>
                  </a:r>
                  <a:r>
                    <a:rPr lang="de-DE" sz="900" b="1" dirty="0" err="1" smtClean="0"/>
                    <a:t>bp</a:t>
                  </a:r>
                  <a:endParaRPr lang="de-DE" sz="900" b="1" dirty="0"/>
                </a:p>
              </p:txBody>
            </p:sp>
            <p:sp>
              <p:nvSpPr>
                <p:cNvPr id="197" name="Textfeld 196"/>
                <p:cNvSpPr txBox="1"/>
                <p:nvPr/>
              </p:nvSpPr>
              <p:spPr>
                <a:xfrm>
                  <a:off x="4804106" y="1757035"/>
                  <a:ext cx="56618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b="1" dirty="0" smtClean="0"/>
                    <a:t>1000 </a:t>
                  </a:r>
                  <a:r>
                    <a:rPr lang="de-DE" sz="900" b="1" dirty="0" err="1" smtClean="0"/>
                    <a:t>bp</a:t>
                  </a:r>
                  <a:endParaRPr lang="de-DE" sz="900" b="1" dirty="0"/>
                </a:p>
              </p:txBody>
            </p:sp>
            <p:sp>
              <p:nvSpPr>
                <p:cNvPr id="198" name="Textfeld 197"/>
                <p:cNvSpPr txBox="1"/>
                <p:nvPr/>
              </p:nvSpPr>
              <p:spPr>
                <a:xfrm>
                  <a:off x="4804107" y="3006586"/>
                  <a:ext cx="56618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b="1" dirty="0" smtClean="0"/>
                    <a:t>3000 </a:t>
                  </a:r>
                  <a:r>
                    <a:rPr lang="de-DE" sz="900" b="1" dirty="0" err="1" smtClean="0"/>
                    <a:t>bp</a:t>
                  </a:r>
                  <a:endParaRPr lang="de-DE" sz="900" b="1" dirty="0"/>
                </a:p>
              </p:txBody>
            </p:sp>
            <p:sp>
              <p:nvSpPr>
                <p:cNvPr id="199" name="Textfeld 198"/>
                <p:cNvSpPr txBox="1"/>
                <p:nvPr/>
              </p:nvSpPr>
              <p:spPr>
                <a:xfrm>
                  <a:off x="4804107" y="2780921"/>
                  <a:ext cx="56618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 b="1" dirty="0" smtClean="0"/>
                    <a:t>4000 </a:t>
                  </a:r>
                  <a:r>
                    <a:rPr lang="de-DE" sz="900" b="1" dirty="0" err="1" smtClean="0"/>
                    <a:t>bp</a:t>
                  </a:r>
                  <a:endParaRPr lang="de-DE" sz="900" b="1" dirty="0"/>
                </a:p>
              </p:txBody>
            </p:sp>
            <p:cxnSp>
              <p:nvCxnSpPr>
                <p:cNvPr id="200" name="Gerade Verbindung 199"/>
                <p:cNvCxnSpPr/>
                <p:nvPr/>
              </p:nvCxnSpPr>
              <p:spPr>
                <a:xfrm flipV="1">
                  <a:off x="4742975" y="2895564"/>
                  <a:ext cx="103663" cy="51175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1" name="Gerade Verbindung 200"/>
                <p:cNvCxnSpPr/>
                <p:nvPr/>
              </p:nvCxnSpPr>
              <p:spPr>
                <a:xfrm>
                  <a:off x="4742975" y="3060842"/>
                  <a:ext cx="103663" cy="6332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35" name="Gruppieren 34"/>
                <p:cNvGrpSpPr/>
                <p:nvPr/>
              </p:nvGrpSpPr>
              <p:grpSpPr>
                <a:xfrm>
                  <a:off x="3396145" y="894651"/>
                  <a:ext cx="1371831" cy="276999"/>
                  <a:chOff x="3396145" y="894651"/>
                  <a:chExt cx="1371831" cy="276999"/>
                </a:xfrm>
              </p:grpSpPr>
              <p:grpSp>
                <p:nvGrpSpPr>
                  <p:cNvPr id="170" name="Gruppieren 169"/>
                  <p:cNvGrpSpPr/>
                  <p:nvPr/>
                </p:nvGrpSpPr>
                <p:grpSpPr>
                  <a:xfrm>
                    <a:off x="3669908" y="894651"/>
                    <a:ext cx="804939" cy="276999"/>
                    <a:chOff x="745028" y="5012628"/>
                    <a:chExt cx="804939" cy="276999"/>
                  </a:xfrm>
                </p:grpSpPr>
                <p:sp>
                  <p:nvSpPr>
                    <p:cNvPr id="171" name="Rechteck 170"/>
                    <p:cNvSpPr/>
                    <p:nvPr/>
                  </p:nvSpPr>
                  <p:spPr>
                    <a:xfrm>
                      <a:off x="1286753" y="5012628"/>
                      <a:ext cx="263214" cy="249840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ctr"/>
                      <a:r>
                        <a:rPr lang="en-US" sz="1200" b="1" u="none" strike="noStrike" dirty="0" smtClean="0">
                          <a:effectLst/>
                        </a:rPr>
                        <a:t>3</a:t>
                      </a:r>
                      <a:endParaRPr lang="en-US" sz="1200" b="1" i="1" dirty="0">
                        <a:solidFill>
                          <a:srgbClr val="000000"/>
                        </a:solidFill>
                      </a:endParaRPr>
                    </a:p>
                  </p:txBody>
                </p:sp>
                <p:sp>
                  <p:nvSpPr>
                    <p:cNvPr id="172" name="Rechteck 171"/>
                    <p:cNvSpPr/>
                    <p:nvPr/>
                  </p:nvSpPr>
                  <p:spPr>
                    <a:xfrm>
                      <a:off x="745028" y="5012628"/>
                      <a:ext cx="263214" cy="249840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ctr"/>
                      <a:r>
                        <a:rPr lang="de-DE" sz="1200" b="1" dirty="0"/>
                        <a:t>1</a:t>
                      </a:r>
                      <a:endParaRPr lang="en-US" sz="1200" b="1" i="1" dirty="0">
                        <a:solidFill>
                          <a:srgbClr val="000000"/>
                        </a:solidFill>
                      </a:endParaRPr>
                    </a:p>
                  </p:txBody>
                </p:sp>
                <p:sp>
                  <p:nvSpPr>
                    <p:cNvPr id="173" name="Rechteck 172"/>
                    <p:cNvSpPr/>
                    <p:nvPr/>
                  </p:nvSpPr>
                  <p:spPr>
                    <a:xfrm>
                      <a:off x="1015890" y="5012628"/>
                      <a:ext cx="263214" cy="276999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ctr"/>
                      <a:r>
                        <a:rPr lang="de-DE" sz="1200" b="1" dirty="0">
                          <a:solidFill>
                            <a:srgbClr val="FF0000"/>
                          </a:solidFill>
                        </a:rPr>
                        <a:t>2</a:t>
                      </a:r>
                      <a:endParaRPr lang="en-US" sz="1200" b="1" dirty="0">
                        <a:solidFill>
                          <a:srgbClr val="FF0000"/>
                        </a:solidFill>
                      </a:endParaRPr>
                    </a:p>
                  </p:txBody>
                </p:sp>
              </p:grpSp>
              <p:sp>
                <p:nvSpPr>
                  <p:cNvPr id="212" name="Rechteck 211"/>
                  <p:cNvSpPr/>
                  <p:nvPr/>
                </p:nvSpPr>
                <p:spPr>
                  <a:xfrm>
                    <a:off x="3396145" y="894651"/>
                    <a:ext cx="31931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 smtClean="0"/>
                      <a:t>M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13" name="Rechteck 212"/>
                  <p:cNvSpPr/>
                  <p:nvPr/>
                </p:nvSpPr>
                <p:spPr>
                  <a:xfrm>
                    <a:off x="4448658" y="894651"/>
                    <a:ext cx="31931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 smtClean="0"/>
                      <a:t>M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</p:grpSp>
            <p:grpSp>
              <p:nvGrpSpPr>
                <p:cNvPr id="38" name="Gruppieren 37"/>
                <p:cNvGrpSpPr/>
                <p:nvPr/>
              </p:nvGrpSpPr>
              <p:grpSpPr>
                <a:xfrm>
                  <a:off x="3381855" y="2556773"/>
                  <a:ext cx="1371831" cy="276999"/>
                  <a:chOff x="3381855" y="2556773"/>
                  <a:chExt cx="1371831" cy="276999"/>
                </a:xfrm>
              </p:grpSpPr>
              <p:grpSp>
                <p:nvGrpSpPr>
                  <p:cNvPr id="174" name="Gruppieren 173"/>
                  <p:cNvGrpSpPr/>
                  <p:nvPr/>
                </p:nvGrpSpPr>
                <p:grpSpPr>
                  <a:xfrm>
                    <a:off x="3669908" y="2556773"/>
                    <a:ext cx="804939" cy="276999"/>
                    <a:chOff x="745028" y="5012628"/>
                    <a:chExt cx="804939" cy="276999"/>
                  </a:xfrm>
                </p:grpSpPr>
                <p:sp>
                  <p:nvSpPr>
                    <p:cNvPr id="175" name="Rechteck 174"/>
                    <p:cNvSpPr/>
                    <p:nvPr/>
                  </p:nvSpPr>
                  <p:spPr>
                    <a:xfrm>
                      <a:off x="1286753" y="5012628"/>
                      <a:ext cx="263214" cy="249840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ctr"/>
                      <a:r>
                        <a:rPr lang="en-US" sz="1200" b="1" u="none" strike="noStrike" dirty="0" smtClean="0">
                          <a:effectLst/>
                        </a:rPr>
                        <a:t>3</a:t>
                      </a:r>
                      <a:endParaRPr lang="en-US" sz="1200" b="1" i="1" dirty="0">
                        <a:solidFill>
                          <a:srgbClr val="000000"/>
                        </a:solidFill>
                      </a:endParaRPr>
                    </a:p>
                  </p:txBody>
                </p:sp>
                <p:sp>
                  <p:nvSpPr>
                    <p:cNvPr id="176" name="Rechteck 175"/>
                    <p:cNvSpPr/>
                    <p:nvPr/>
                  </p:nvSpPr>
                  <p:spPr>
                    <a:xfrm>
                      <a:off x="745028" y="5012628"/>
                      <a:ext cx="263214" cy="249840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ctr"/>
                      <a:r>
                        <a:rPr lang="de-DE" sz="1200" b="1" dirty="0"/>
                        <a:t>1</a:t>
                      </a:r>
                      <a:endParaRPr lang="en-US" sz="1200" b="1" i="1" dirty="0">
                        <a:solidFill>
                          <a:srgbClr val="000000"/>
                        </a:solidFill>
                      </a:endParaRPr>
                    </a:p>
                  </p:txBody>
                </p:sp>
                <p:sp>
                  <p:nvSpPr>
                    <p:cNvPr id="177" name="Rechteck 176"/>
                    <p:cNvSpPr/>
                    <p:nvPr/>
                  </p:nvSpPr>
                  <p:spPr>
                    <a:xfrm>
                      <a:off x="1015890" y="5012628"/>
                      <a:ext cx="263214" cy="276999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ctr"/>
                      <a:r>
                        <a:rPr lang="de-DE" sz="1200" b="1" dirty="0">
                          <a:solidFill>
                            <a:srgbClr val="FF0000"/>
                          </a:solidFill>
                        </a:rPr>
                        <a:t>2</a:t>
                      </a:r>
                      <a:endParaRPr lang="en-US" sz="1200" b="1" dirty="0">
                        <a:solidFill>
                          <a:srgbClr val="FF0000"/>
                        </a:solidFill>
                      </a:endParaRPr>
                    </a:p>
                  </p:txBody>
                </p:sp>
              </p:grpSp>
              <p:sp>
                <p:nvSpPr>
                  <p:cNvPr id="214" name="Rechteck 213"/>
                  <p:cNvSpPr/>
                  <p:nvPr/>
                </p:nvSpPr>
                <p:spPr>
                  <a:xfrm>
                    <a:off x="3381855" y="2556773"/>
                    <a:ext cx="31931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 smtClean="0"/>
                      <a:t>M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15" name="Rechteck 214"/>
                  <p:cNvSpPr/>
                  <p:nvPr/>
                </p:nvSpPr>
                <p:spPr>
                  <a:xfrm>
                    <a:off x="4434368" y="2556773"/>
                    <a:ext cx="31931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 smtClean="0"/>
                      <a:t>M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</p:grpSp>
          </p:grpSp>
        </p:grpSp>
        <p:grpSp>
          <p:nvGrpSpPr>
            <p:cNvPr id="88" name="Gruppieren 87"/>
            <p:cNvGrpSpPr/>
            <p:nvPr/>
          </p:nvGrpSpPr>
          <p:grpSpPr>
            <a:xfrm>
              <a:off x="-47703" y="4263419"/>
              <a:ext cx="6970565" cy="3312649"/>
              <a:chOff x="-47703" y="4568219"/>
              <a:chExt cx="6970565" cy="3312649"/>
            </a:xfrm>
          </p:grpSpPr>
          <p:sp>
            <p:nvSpPr>
              <p:cNvPr id="219" name="Textfeld 218"/>
              <p:cNvSpPr txBox="1"/>
              <p:nvPr/>
            </p:nvSpPr>
            <p:spPr>
              <a:xfrm>
                <a:off x="2494" y="4568219"/>
                <a:ext cx="402674" cy="5847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3200" b="1" dirty="0" smtClean="0"/>
                  <a:t>C</a:t>
                </a:r>
                <a:endParaRPr lang="en-US" sz="3200" b="1" dirty="0"/>
              </a:p>
            </p:txBody>
          </p:sp>
          <p:grpSp>
            <p:nvGrpSpPr>
              <p:cNvPr id="56" name="Gruppieren 55"/>
              <p:cNvGrpSpPr/>
              <p:nvPr/>
            </p:nvGrpSpPr>
            <p:grpSpPr>
              <a:xfrm>
                <a:off x="4780529" y="4683123"/>
                <a:ext cx="2142333" cy="3197745"/>
                <a:chOff x="4780529" y="4683123"/>
                <a:chExt cx="2142333" cy="3197745"/>
              </a:xfrm>
            </p:grpSpPr>
            <p:grpSp>
              <p:nvGrpSpPr>
                <p:cNvPr id="226" name="Gruppieren 225"/>
                <p:cNvGrpSpPr/>
                <p:nvPr/>
              </p:nvGrpSpPr>
              <p:grpSpPr>
                <a:xfrm>
                  <a:off x="4780529" y="4683123"/>
                  <a:ext cx="1625446" cy="680740"/>
                  <a:chOff x="618104" y="215898"/>
                  <a:chExt cx="1625446" cy="680740"/>
                </a:xfrm>
              </p:grpSpPr>
              <p:sp>
                <p:nvSpPr>
                  <p:cNvPr id="227" name="Textfeld 226"/>
                  <p:cNvSpPr txBox="1"/>
                  <p:nvPr/>
                </p:nvSpPr>
                <p:spPr>
                  <a:xfrm>
                    <a:off x="1114581" y="215898"/>
                    <a:ext cx="632481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de-DE" sz="1400" b="1" dirty="0" err="1" smtClean="0"/>
                      <a:t>RepW</a:t>
                    </a:r>
                    <a:endParaRPr lang="de-DE" sz="1400" b="1" dirty="0" smtClean="0"/>
                  </a:p>
                </p:txBody>
              </p:sp>
              <p:sp>
                <p:nvSpPr>
                  <p:cNvPr id="228" name="Textfeld 227"/>
                  <p:cNvSpPr txBox="1"/>
                  <p:nvPr/>
                </p:nvSpPr>
                <p:spPr>
                  <a:xfrm>
                    <a:off x="618104" y="434973"/>
                    <a:ext cx="1625446" cy="4616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de-DE" sz="1200" i="1" dirty="0" err="1" smtClean="0"/>
                      <a:t>Pseudosulfitobacter</a:t>
                    </a:r>
                    <a:r>
                      <a:rPr lang="de-DE" sz="1200" i="1" dirty="0" smtClean="0"/>
                      <a:t> </a:t>
                    </a:r>
                    <a:r>
                      <a:rPr lang="de-DE" sz="1200" dirty="0" err="1" smtClean="0"/>
                      <a:t>sp</a:t>
                    </a:r>
                    <a:r>
                      <a:rPr lang="de-DE" sz="1200" dirty="0" smtClean="0"/>
                      <a:t>.</a:t>
                    </a:r>
                    <a:endParaRPr lang="de-DE" sz="1200" dirty="0"/>
                  </a:p>
                  <a:p>
                    <a:pPr algn="ctr"/>
                    <a:r>
                      <a:rPr lang="de-DE" sz="1200" dirty="0" smtClean="0"/>
                      <a:t>DSM 107133</a:t>
                    </a:r>
                  </a:p>
                </p:txBody>
              </p:sp>
            </p:grpSp>
            <p:grpSp>
              <p:nvGrpSpPr>
                <p:cNvPr id="54" name="Gruppieren 53"/>
                <p:cNvGrpSpPr/>
                <p:nvPr/>
              </p:nvGrpSpPr>
              <p:grpSpPr>
                <a:xfrm>
                  <a:off x="4886805" y="5419026"/>
                  <a:ext cx="2036057" cy="2461842"/>
                  <a:chOff x="4886805" y="5419026"/>
                  <a:chExt cx="2036057" cy="2461842"/>
                </a:xfrm>
              </p:grpSpPr>
              <p:pic>
                <p:nvPicPr>
                  <p:cNvPr id="229" name="Picture 3" descr="N:\dept\AG-Roseobacter\Vicky\Gelelektrophorese\2021\10 Oktober\2021-10-28_Replikationssysteme RV und PCR_3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brightnessContrast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2668" t="49196" r="39223" b="31681"/>
                  <a:stretch/>
                </p:blipFill>
                <p:spPr bwMode="auto">
                  <a:xfrm>
                    <a:off x="4924425" y="5457825"/>
                    <a:ext cx="1362075" cy="1438275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30" name="Picture 3" descr="N:\dept\AG-Roseobacter\Vicky\Gelelektrophorese\2021\10 Oktober\2021-10-28_Replikationssysteme RV und PCR_3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brightnessContrast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2668" t="20829" r="39857" b="72839"/>
                  <a:stretch/>
                </p:blipFill>
                <p:spPr bwMode="auto">
                  <a:xfrm>
                    <a:off x="4924425" y="7353301"/>
                    <a:ext cx="1314450" cy="476249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grpSp>
                <p:nvGrpSpPr>
                  <p:cNvPr id="43" name="Gruppieren 42"/>
                  <p:cNvGrpSpPr/>
                  <p:nvPr/>
                </p:nvGrpSpPr>
                <p:grpSpPr>
                  <a:xfrm>
                    <a:off x="4886805" y="5419026"/>
                    <a:ext cx="2036057" cy="2461842"/>
                    <a:chOff x="4839180" y="5419026"/>
                    <a:chExt cx="2036057" cy="2461842"/>
                  </a:xfrm>
                </p:grpSpPr>
                <p:grpSp>
                  <p:nvGrpSpPr>
                    <p:cNvPr id="40" name="Gruppieren 39"/>
                    <p:cNvGrpSpPr/>
                    <p:nvPr/>
                  </p:nvGrpSpPr>
                  <p:grpSpPr>
                    <a:xfrm>
                      <a:off x="6254270" y="5799141"/>
                      <a:ext cx="620967" cy="698812"/>
                      <a:chOff x="6254270" y="5799141"/>
                      <a:chExt cx="620967" cy="698812"/>
                    </a:xfrm>
                  </p:grpSpPr>
                  <p:cxnSp>
                    <p:nvCxnSpPr>
                      <p:cNvPr id="233" name="Gerade Verbindung 232"/>
                      <p:cNvCxnSpPr/>
                      <p:nvPr/>
                    </p:nvCxnSpPr>
                    <p:spPr>
                      <a:xfrm>
                        <a:off x="6254270" y="6132895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34" name="Gerade Verbindung 233"/>
                      <p:cNvCxnSpPr/>
                      <p:nvPr/>
                    </p:nvCxnSpPr>
                    <p:spPr>
                      <a:xfrm>
                        <a:off x="6254270" y="5909257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35" name="Gerade Verbindung 234"/>
                      <p:cNvCxnSpPr/>
                      <p:nvPr/>
                    </p:nvCxnSpPr>
                    <p:spPr>
                      <a:xfrm>
                        <a:off x="6259033" y="637558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36" name="Textfeld 235"/>
                      <p:cNvSpPr txBox="1"/>
                      <p:nvPr/>
                    </p:nvSpPr>
                    <p:spPr>
                      <a:xfrm>
                        <a:off x="6309056" y="5799141"/>
                        <a:ext cx="566181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de-DE" sz="900" b="1" dirty="0" smtClean="0"/>
                          <a:t>4000 </a:t>
                        </a:r>
                        <a:r>
                          <a:rPr lang="de-DE" sz="900" b="1" dirty="0" err="1" smtClean="0"/>
                          <a:t>bp</a:t>
                        </a:r>
                        <a:endParaRPr lang="de-DE" sz="900" b="1" dirty="0"/>
                      </a:p>
                    </p:txBody>
                  </p:sp>
                  <p:sp>
                    <p:nvSpPr>
                      <p:cNvPr id="237" name="Textfeld 236"/>
                      <p:cNvSpPr txBox="1"/>
                      <p:nvPr/>
                    </p:nvSpPr>
                    <p:spPr>
                      <a:xfrm>
                        <a:off x="6309056" y="6021288"/>
                        <a:ext cx="566181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de-DE" sz="900" b="1" dirty="0" smtClean="0"/>
                          <a:t>2000 </a:t>
                        </a:r>
                        <a:r>
                          <a:rPr lang="de-DE" sz="900" b="1" dirty="0" err="1" smtClean="0"/>
                          <a:t>bp</a:t>
                        </a:r>
                        <a:endParaRPr lang="de-DE" sz="900" b="1" dirty="0"/>
                      </a:p>
                    </p:txBody>
                  </p:sp>
                  <p:sp>
                    <p:nvSpPr>
                      <p:cNvPr id="238" name="Textfeld 237"/>
                      <p:cNvSpPr txBox="1"/>
                      <p:nvPr/>
                    </p:nvSpPr>
                    <p:spPr>
                      <a:xfrm>
                        <a:off x="6309056" y="6267121"/>
                        <a:ext cx="566181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de-DE" sz="900" b="1" dirty="0" smtClean="0"/>
                          <a:t>1000 </a:t>
                        </a:r>
                        <a:r>
                          <a:rPr lang="de-DE" sz="900" b="1" dirty="0" err="1" smtClean="0"/>
                          <a:t>bp</a:t>
                        </a:r>
                        <a:endParaRPr lang="de-DE" sz="900" b="1" dirty="0"/>
                      </a:p>
                    </p:txBody>
                  </p:sp>
                </p:grpSp>
                <p:grpSp>
                  <p:nvGrpSpPr>
                    <p:cNvPr id="41" name="Gruppieren 40"/>
                    <p:cNvGrpSpPr/>
                    <p:nvPr/>
                  </p:nvGrpSpPr>
                  <p:grpSpPr>
                    <a:xfrm>
                      <a:off x="6209824" y="7448186"/>
                      <a:ext cx="627313" cy="432682"/>
                      <a:chOff x="6209824" y="7448186"/>
                      <a:chExt cx="627313" cy="432682"/>
                    </a:xfrm>
                  </p:grpSpPr>
                  <p:sp>
                    <p:nvSpPr>
                      <p:cNvPr id="239" name="Textfeld 238"/>
                      <p:cNvSpPr txBox="1"/>
                      <p:nvPr/>
                    </p:nvSpPr>
                    <p:spPr>
                      <a:xfrm>
                        <a:off x="6270956" y="7650036"/>
                        <a:ext cx="566181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de-DE" sz="900" b="1" dirty="0" smtClean="0"/>
                          <a:t>1500 </a:t>
                        </a:r>
                        <a:r>
                          <a:rPr lang="de-DE" sz="900" b="1" dirty="0" err="1" smtClean="0"/>
                          <a:t>bp</a:t>
                        </a:r>
                        <a:endParaRPr lang="de-DE" sz="900" b="1" dirty="0"/>
                      </a:p>
                    </p:txBody>
                  </p:sp>
                  <p:sp>
                    <p:nvSpPr>
                      <p:cNvPr id="240" name="Textfeld 239"/>
                      <p:cNvSpPr txBox="1"/>
                      <p:nvPr/>
                    </p:nvSpPr>
                    <p:spPr>
                      <a:xfrm>
                        <a:off x="6270956" y="7448186"/>
                        <a:ext cx="566181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de-DE" sz="900" b="1" dirty="0" smtClean="0"/>
                          <a:t>2000 </a:t>
                        </a:r>
                        <a:r>
                          <a:rPr lang="de-DE" sz="900" b="1" dirty="0" err="1" smtClean="0"/>
                          <a:t>bp</a:t>
                        </a:r>
                        <a:endParaRPr lang="de-DE" sz="900" b="1" dirty="0"/>
                      </a:p>
                    </p:txBody>
                  </p:sp>
                  <p:cxnSp>
                    <p:nvCxnSpPr>
                      <p:cNvPr id="241" name="Gerade Verbindung 240"/>
                      <p:cNvCxnSpPr/>
                      <p:nvPr/>
                    </p:nvCxnSpPr>
                    <p:spPr>
                      <a:xfrm flipV="1">
                        <a:off x="6209824" y="7562829"/>
                        <a:ext cx="103663" cy="51175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42" name="Gerade Verbindung 241"/>
                      <p:cNvCxnSpPr/>
                      <p:nvPr/>
                    </p:nvCxnSpPr>
                    <p:spPr>
                      <a:xfrm>
                        <a:off x="6209824" y="7704292"/>
                        <a:ext cx="103663" cy="63328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243" name="Gruppieren 242"/>
                    <p:cNvGrpSpPr/>
                    <p:nvPr/>
                  </p:nvGrpSpPr>
                  <p:grpSpPr>
                    <a:xfrm>
                      <a:off x="4872520" y="5419026"/>
                      <a:ext cx="1371831" cy="276999"/>
                      <a:chOff x="3396145" y="894651"/>
                      <a:chExt cx="1371831" cy="276999"/>
                    </a:xfrm>
                  </p:grpSpPr>
                  <p:grpSp>
                    <p:nvGrpSpPr>
                      <p:cNvPr id="244" name="Gruppieren 243"/>
                      <p:cNvGrpSpPr/>
                      <p:nvPr/>
                    </p:nvGrpSpPr>
                    <p:grpSpPr>
                      <a:xfrm>
                        <a:off x="3669908" y="894651"/>
                        <a:ext cx="804939" cy="276999"/>
                        <a:chOff x="745028" y="5012628"/>
                        <a:chExt cx="804939" cy="276999"/>
                      </a:xfrm>
                    </p:grpSpPr>
                    <p:sp>
                      <p:nvSpPr>
                        <p:cNvPr id="247" name="Rechteck 246"/>
                        <p:cNvSpPr/>
                        <p:nvPr/>
                      </p:nvSpPr>
                      <p:spPr>
                        <a:xfrm>
                          <a:off x="1286753" y="5012628"/>
                          <a:ext cx="263214" cy="249840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fontAlgn="ctr"/>
                          <a:r>
                            <a:rPr lang="en-US" sz="1200" b="1" u="none" strike="noStrike" dirty="0" smtClean="0">
                              <a:effectLst/>
                            </a:rPr>
                            <a:t>3</a:t>
                          </a:r>
                          <a:endParaRPr lang="en-US" sz="1200" b="1" i="1" dirty="0">
                            <a:solidFill>
                              <a:srgbClr val="000000"/>
                            </a:solidFill>
                          </a:endParaRPr>
                        </a:p>
                      </p:txBody>
                    </p:sp>
                    <p:sp>
                      <p:nvSpPr>
                        <p:cNvPr id="248" name="Rechteck 247"/>
                        <p:cNvSpPr/>
                        <p:nvPr/>
                      </p:nvSpPr>
                      <p:spPr>
                        <a:xfrm>
                          <a:off x="745028" y="5012628"/>
                          <a:ext cx="263214" cy="249840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fontAlgn="ctr"/>
                          <a:r>
                            <a:rPr lang="de-DE" sz="1200" b="1" dirty="0"/>
                            <a:t>1</a:t>
                          </a:r>
                          <a:endParaRPr lang="en-US" sz="1200" b="1" i="1" dirty="0">
                            <a:solidFill>
                              <a:srgbClr val="000000"/>
                            </a:solidFill>
                          </a:endParaRPr>
                        </a:p>
                      </p:txBody>
                    </p:sp>
                    <p:sp>
                      <p:nvSpPr>
                        <p:cNvPr id="249" name="Rechteck 248"/>
                        <p:cNvSpPr/>
                        <p:nvPr/>
                      </p:nvSpPr>
                      <p:spPr>
                        <a:xfrm>
                          <a:off x="1015890" y="5012628"/>
                          <a:ext cx="263214" cy="276999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fontAlgn="ctr"/>
                          <a:r>
                            <a:rPr lang="de-DE" sz="1200" b="1" dirty="0">
                              <a:solidFill>
                                <a:srgbClr val="FF0000"/>
                              </a:solidFill>
                            </a:rPr>
                            <a:t>2</a:t>
                          </a:r>
                          <a:endParaRPr lang="en-US" sz="1200" b="1" dirty="0">
                            <a:solidFill>
                              <a:srgbClr val="FF0000"/>
                            </a:solidFill>
                          </a:endParaRPr>
                        </a:p>
                      </p:txBody>
                    </p:sp>
                  </p:grpSp>
                  <p:sp>
                    <p:nvSpPr>
                      <p:cNvPr id="245" name="Rechteck 244"/>
                      <p:cNvSpPr/>
                      <p:nvPr/>
                    </p:nvSpPr>
                    <p:spPr>
                      <a:xfrm>
                        <a:off x="3396145" y="894651"/>
                        <a:ext cx="319318" cy="276999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fontAlgn="ctr"/>
                        <a:r>
                          <a:rPr lang="de-DE" sz="1200" b="1" dirty="0" smtClean="0"/>
                          <a:t>M</a:t>
                        </a:r>
                        <a:endParaRPr lang="en-US" sz="1200" b="1" i="1" dirty="0">
                          <a:solidFill>
                            <a:srgbClr val="000000"/>
                          </a:solidFill>
                        </a:endParaRPr>
                      </a:p>
                    </p:txBody>
                  </p:sp>
                  <p:sp>
                    <p:nvSpPr>
                      <p:cNvPr id="246" name="Rechteck 245"/>
                      <p:cNvSpPr/>
                      <p:nvPr/>
                    </p:nvSpPr>
                    <p:spPr>
                      <a:xfrm>
                        <a:off x="4448658" y="894651"/>
                        <a:ext cx="319318" cy="276999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fontAlgn="ctr"/>
                        <a:r>
                          <a:rPr lang="de-DE" sz="1200" b="1" dirty="0" smtClean="0"/>
                          <a:t>M</a:t>
                        </a:r>
                        <a:endParaRPr lang="en-US" sz="1200" b="1" i="1" dirty="0">
                          <a:solidFill>
                            <a:srgbClr val="000000"/>
                          </a:solidFill>
                        </a:endParaRPr>
                      </a:p>
                    </p:txBody>
                  </p:sp>
                </p:grpSp>
                <p:grpSp>
                  <p:nvGrpSpPr>
                    <p:cNvPr id="250" name="Gruppieren 249"/>
                    <p:cNvGrpSpPr/>
                    <p:nvPr/>
                  </p:nvGrpSpPr>
                  <p:grpSpPr>
                    <a:xfrm>
                      <a:off x="4839180" y="7081148"/>
                      <a:ext cx="1371831" cy="276999"/>
                      <a:chOff x="3381855" y="2556773"/>
                      <a:chExt cx="1371831" cy="276999"/>
                    </a:xfrm>
                  </p:grpSpPr>
                  <p:grpSp>
                    <p:nvGrpSpPr>
                      <p:cNvPr id="251" name="Gruppieren 250"/>
                      <p:cNvGrpSpPr/>
                      <p:nvPr/>
                    </p:nvGrpSpPr>
                    <p:grpSpPr>
                      <a:xfrm>
                        <a:off x="3669908" y="2556773"/>
                        <a:ext cx="804939" cy="276999"/>
                        <a:chOff x="745028" y="5012628"/>
                        <a:chExt cx="804939" cy="276999"/>
                      </a:xfrm>
                    </p:grpSpPr>
                    <p:sp>
                      <p:nvSpPr>
                        <p:cNvPr id="254" name="Rechteck 253"/>
                        <p:cNvSpPr/>
                        <p:nvPr/>
                      </p:nvSpPr>
                      <p:spPr>
                        <a:xfrm>
                          <a:off x="1286753" y="5012628"/>
                          <a:ext cx="263214" cy="249840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fontAlgn="ctr"/>
                          <a:r>
                            <a:rPr lang="en-US" sz="1200" b="1" u="none" strike="noStrike" dirty="0" smtClean="0">
                              <a:effectLst/>
                            </a:rPr>
                            <a:t>3</a:t>
                          </a:r>
                          <a:endParaRPr lang="en-US" sz="1200" b="1" i="1" dirty="0">
                            <a:solidFill>
                              <a:srgbClr val="000000"/>
                            </a:solidFill>
                          </a:endParaRPr>
                        </a:p>
                      </p:txBody>
                    </p:sp>
                    <p:sp>
                      <p:nvSpPr>
                        <p:cNvPr id="255" name="Rechteck 254"/>
                        <p:cNvSpPr/>
                        <p:nvPr/>
                      </p:nvSpPr>
                      <p:spPr>
                        <a:xfrm>
                          <a:off x="745028" y="5012628"/>
                          <a:ext cx="263214" cy="249840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fontAlgn="ctr"/>
                          <a:r>
                            <a:rPr lang="de-DE" sz="1200" b="1" dirty="0"/>
                            <a:t>1</a:t>
                          </a:r>
                          <a:endParaRPr lang="en-US" sz="1200" b="1" i="1" dirty="0">
                            <a:solidFill>
                              <a:srgbClr val="000000"/>
                            </a:solidFill>
                          </a:endParaRPr>
                        </a:p>
                      </p:txBody>
                    </p:sp>
                    <p:sp>
                      <p:nvSpPr>
                        <p:cNvPr id="256" name="Rechteck 255"/>
                        <p:cNvSpPr/>
                        <p:nvPr/>
                      </p:nvSpPr>
                      <p:spPr>
                        <a:xfrm>
                          <a:off x="1015890" y="5012628"/>
                          <a:ext cx="263214" cy="276999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pPr fontAlgn="ctr"/>
                          <a:r>
                            <a:rPr lang="de-DE" sz="1200" b="1" dirty="0">
                              <a:solidFill>
                                <a:srgbClr val="FF0000"/>
                              </a:solidFill>
                            </a:rPr>
                            <a:t>2</a:t>
                          </a:r>
                          <a:endParaRPr lang="en-US" sz="1200" b="1" dirty="0">
                            <a:solidFill>
                              <a:srgbClr val="FF0000"/>
                            </a:solidFill>
                          </a:endParaRPr>
                        </a:p>
                      </p:txBody>
                    </p:sp>
                  </p:grpSp>
                  <p:sp>
                    <p:nvSpPr>
                      <p:cNvPr id="252" name="Rechteck 251"/>
                      <p:cNvSpPr/>
                      <p:nvPr/>
                    </p:nvSpPr>
                    <p:spPr>
                      <a:xfrm>
                        <a:off x="3381855" y="2556773"/>
                        <a:ext cx="319318" cy="276999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fontAlgn="ctr"/>
                        <a:r>
                          <a:rPr lang="de-DE" sz="1200" b="1" dirty="0" smtClean="0"/>
                          <a:t>M</a:t>
                        </a:r>
                        <a:endParaRPr lang="en-US" sz="1200" b="1" i="1" dirty="0">
                          <a:solidFill>
                            <a:srgbClr val="000000"/>
                          </a:solidFill>
                        </a:endParaRPr>
                      </a:p>
                    </p:txBody>
                  </p:sp>
                  <p:sp>
                    <p:nvSpPr>
                      <p:cNvPr id="253" name="Rechteck 252"/>
                      <p:cNvSpPr/>
                      <p:nvPr/>
                    </p:nvSpPr>
                    <p:spPr>
                      <a:xfrm>
                        <a:off x="4434368" y="2556773"/>
                        <a:ext cx="319318" cy="276999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fontAlgn="ctr"/>
                        <a:r>
                          <a:rPr lang="de-DE" sz="1200" b="1" dirty="0" smtClean="0"/>
                          <a:t>M</a:t>
                        </a:r>
                        <a:endParaRPr lang="en-US" sz="1200" b="1" i="1" dirty="0">
                          <a:solidFill>
                            <a:srgbClr val="000000"/>
                          </a:solidFill>
                        </a:endParaRPr>
                      </a:p>
                    </p:txBody>
                  </p:sp>
                </p:grpSp>
              </p:grpSp>
            </p:grpSp>
          </p:grpSp>
          <p:grpSp>
            <p:nvGrpSpPr>
              <p:cNvPr id="58" name="Gruppieren 57"/>
              <p:cNvGrpSpPr/>
              <p:nvPr/>
            </p:nvGrpSpPr>
            <p:grpSpPr>
              <a:xfrm>
                <a:off x="-47703" y="4683123"/>
                <a:ext cx="2541440" cy="3146430"/>
                <a:chOff x="-104853" y="4683123"/>
                <a:chExt cx="2541440" cy="3146430"/>
              </a:xfrm>
            </p:grpSpPr>
            <p:grpSp>
              <p:nvGrpSpPr>
                <p:cNvPr id="220" name="Gruppieren 219"/>
                <p:cNvGrpSpPr/>
                <p:nvPr/>
              </p:nvGrpSpPr>
              <p:grpSpPr>
                <a:xfrm>
                  <a:off x="632138" y="4683123"/>
                  <a:ext cx="987771" cy="680740"/>
                  <a:chOff x="936938" y="215898"/>
                  <a:chExt cx="987771" cy="680740"/>
                </a:xfrm>
              </p:grpSpPr>
              <p:sp>
                <p:nvSpPr>
                  <p:cNvPr id="221" name="Textfeld 220"/>
                  <p:cNvSpPr txBox="1"/>
                  <p:nvPr/>
                </p:nvSpPr>
                <p:spPr>
                  <a:xfrm>
                    <a:off x="1114581" y="215898"/>
                    <a:ext cx="632481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de-DE" sz="1400" b="1" dirty="0" err="1" smtClean="0"/>
                      <a:t>RepW</a:t>
                    </a:r>
                    <a:endParaRPr lang="de-DE" sz="1400" b="1" dirty="0" smtClean="0"/>
                  </a:p>
                </p:txBody>
              </p:sp>
              <p:sp>
                <p:nvSpPr>
                  <p:cNvPr id="222" name="Textfeld 221"/>
                  <p:cNvSpPr txBox="1"/>
                  <p:nvPr/>
                </p:nvSpPr>
                <p:spPr>
                  <a:xfrm>
                    <a:off x="936938" y="434973"/>
                    <a:ext cx="987771" cy="4616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de-DE" sz="1200" i="1" dirty="0" smtClean="0"/>
                      <a:t>S. </a:t>
                    </a:r>
                    <a:r>
                      <a:rPr lang="de-DE" sz="1200" i="1" dirty="0" err="1" smtClean="0"/>
                      <a:t>dubius</a:t>
                    </a:r>
                    <a:endParaRPr lang="de-DE" sz="1200" i="1" dirty="0"/>
                  </a:p>
                  <a:p>
                    <a:pPr algn="ctr"/>
                    <a:r>
                      <a:rPr lang="de-DE" sz="1200" dirty="0" smtClean="0"/>
                      <a:t>DSM 109990</a:t>
                    </a:r>
                  </a:p>
                </p:txBody>
              </p:sp>
            </p:grpSp>
            <p:grpSp>
              <p:nvGrpSpPr>
                <p:cNvPr id="55" name="Gruppieren 54"/>
                <p:cNvGrpSpPr/>
                <p:nvPr/>
              </p:nvGrpSpPr>
              <p:grpSpPr>
                <a:xfrm>
                  <a:off x="-104853" y="5419026"/>
                  <a:ext cx="2541440" cy="2410527"/>
                  <a:chOff x="-104853" y="5419026"/>
                  <a:chExt cx="2541440" cy="2410527"/>
                </a:xfrm>
              </p:grpSpPr>
              <p:pic>
                <p:nvPicPr>
                  <p:cNvPr id="257" name="Picture 2" descr="N:\dept\AG-Roseobacter\Vicky\Gelelektrophorese\2021\01 Jan\2021-01-18 RepABC PCr auf Ecoli Klone, RV von Konstrukt C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4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saturation sat="40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7602" t="12559" r="13197" b="68702"/>
                  <a:stretch/>
                </p:blipFill>
                <p:spPr bwMode="auto">
                  <a:xfrm>
                    <a:off x="472902" y="5457825"/>
                    <a:ext cx="1327323" cy="129540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58" name="Picture 3" descr="N:\dept\AG-Roseobacter\Vicky\Gelelektrophorese\2021\01 Jan\2021-01-19_D,E RV und C,D,E PCR 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6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saturation sat="40000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3741" t="52092" r="30206" b="41053"/>
                  <a:stretch/>
                </p:blipFill>
                <p:spPr bwMode="auto">
                  <a:xfrm>
                    <a:off x="472902" y="7353301"/>
                    <a:ext cx="1115236" cy="476252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260" name="Rechteck 259"/>
                  <p:cNvSpPr/>
                  <p:nvPr/>
                </p:nvSpPr>
                <p:spPr>
                  <a:xfrm>
                    <a:off x="-104853" y="5419026"/>
                    <a:ext cx="533095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 fontAlgn="ctr"/>
                    <a:r>
                      <a:rPr lang="de-DE" sz="1200" b="1" dirty="0" err="1" smtClean="0"/>
                      <a:t>EcoRI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61" name="Rechteck 260"/>
                  <p:cNvSpPr/>
                  <p:nvPr/>
                </p:nvSpPr>
                <p:spPr>
                  <a:xfrm>
                    <a:off x="-2682" y="7081148"/>
                    <a:ext cx="43473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 smtClean="0"/>
                      <a:t>PCR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grpSp>
                <p:nvGrpSpPr>
                  <p:cNvPr id="44" name="Gruppieren 43"/>
                  <p:cNvGrpSpPr/>
                  <p:nvPr/>
                </p:nvGrpSpPr>
                <p:grpSpPr>
                  <a:xfrm>
                    <a:off x="1815620" y="5761041"/>
                    <a:ext cx="620967" cy="613087"/>
                    <a:chOff x="1815620" y="5761041"/>
                    <a:chExt cx="620967" cy="613087"/>
                  </a:xfrm>
                </p:grpSpPr>
                <p:cxnSp>
                  <p:nvCxnSpPr>
                    <p:cNvPr id="282" name="Gerade Verbindung 281"/>
                    <p:cNvCxnSpPr/>
                    <p:nvPr/>
                  </p:nvCxnSpPr>
                  <p:spPr>
                    <a:xfrm>
                      <a:off x="1815620" y="6047170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3" name="Gerade Verbindung 282"/>
                    <p:cNvCxnSpPr/>
                    <p:nvPr/>
                  </p:nvCxnSpPr>
                  <p:spPr>
                    <a:xfrm>
                      <a:off x="1815620" y="5871157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4" name="Gerade Verbindung 283"/>
                    <p:cNvCxnSpPr/>
                    <p:nvPr/>
                  </p:nvCxnSpPr>
                  <p:spPr>
                    <a:xfrm>
                      <a:off x="1820383" y="6251758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85" name="Textfeld 284"/>
                    <p:cNvSpPr txBox="1"/>
                    <p:nvPr/>
                  </p:nvSpPr>
                  <p:spPr>
                    <a:xfrm>
                      <a:off x="1870406" y="5761041"/>
                      <a:ext cx="56618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b="1" dirty="0" smtClean="0"/>
                        <a:t>4000 </a:t>
                      </a:r>
                      <a:r>
                        <a:rPr lang="de-DE" sz="900" b="1" dirty="0" err="1" smtClean="0"/>
                        <a:t>bp</a:t>
                      </a:r>
                      <a:endParaRPr lang="de-DE" sz="900" b="1" dirty="0"/>
                    </a:p>
                  </p:txBody>
                </p:sp>
                <p:sp>
                  <p:nvSpPr>
                    <p:cNvPr id="286" name="Textfeld 285"/>
                    <p:cNvSpPr txBox="1"/>
                    <p:nvPr/>
                  </p:nvSpPr>
                  <p:spPr>
                    <a:xfrm>
                      <a:off x="1870406" y="5935563"/>
                      <a:ext cx="56618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b="1" dirty="0" smtClean="0"/>
                        <a:t>2000 </a:t>
                      </a:r>
                      <a:r>
                        <a:rPr lang="de-DE" sz="900" b="1" dirty="0" err="1" smtClean="0"/>
                        <a:t>bp</a:t>
                      </a:r>
                      <a:endParaRPr lang="de-DE" sz="900" b="1" dirty="0"/>
                    </a:p>
                  </p:txBody>
                </p:sp>
                <p:sp>
                  <p:nvSpPr>
                    <p:cNvPr id="287" name="Textfeld 286"/>
                    <p:cNvSpPr txBox="1"/>
                    <p:nvPr/>
                  </p:nvSpPr>
                  <p:spPr>
                    <a:xfrm>
                      <a:off x="1870406" y="6143296"/>
                      <a:ext cx="56618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b="1" dirty="0" smtClean="0"/>
                        <a:t>1000 </a:t>
                      </a:r>
                      <a:r>
                        <a:rPr lang="de-DE" sz="900" b="1" dirty="0" err="1" smtClean="0"/>
                        <a:t>bp</a:t>
                      </a:r>
                      <a:endParaRPr lang="de-DE" sz="900" b="1" dirty="0"/>
                    </a:p>
                  </p:txBody>
                </p:sp>
              </p:grpSp>
              <p:grpSp>
                <p:nvGrpSpPr>
                  <p:cNvPr id="45" name="Gruppieren 44"/>
                  <p:cNvGrpSpPr/>
                  <p:nvPr/>
                </p:nvGrpSpPr>
                <p:grpSpPr>
                  <a:xfrm>
                    <a:off x="1618774" y="7305311"/>
                    <a:ext cx="627313" cy="470782"/>
                    <a:chOff x="1618774" y="7305311"/>
                    <a:chExt cx="627313" cy="470782"/>
                  </a:xfrm>
                </p:grpSpPr>
                <p:sp>
                  <p:nvSpPr>
                    <p:cNvPr id="278" name="Textfeld 277"/>
                    <p:cNvSpPr txBox="1"/>
                    <p:nvPr/>
                  </p:nvSpPr>
                  <p:spPr>
                    <a:xfrm>
                      <a:off x="1679906" y="7545261"/>
                      <a:ext cx="56618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b="1" dirty="0" smtClean="0"/>
                        <a:t>2000 </a:t>
                      </a:r>
                      <a:r>
                        <a:rPr lang="de-DE" sz="900" b="1" dirty="0" err="1" smtClean="0"/>
                        <a:t>bp</a:t>
                      </a:r>
                      <a:endParaRPr lang="de-DE" sz="900" b="1" dirty="0"/>
                    </a:p>
                  </p:txBody>
                </p:sp>
                <p:sp>
                  <p:nvSpPr>
                    <p:cNvPr id="279" name="Textfeld 278"/>
                    <p:cNvSpPr txBox="1"/>
                    <p:nvPr/>
                  </p:nvSpPr>
                  <p:spPr>
                    <a:xfrm>
                      <a:off x="1679906" y="7305311"/>
                      <a:ext cx="56618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b="1" dirty="0" smtClean="0"/>
                        <a:t>3000 </a:t>
                      </a:r>
                      <a:r>
                        <a:rPr lang="de-DE" sz="900" b="1" dirty="0" err="1" smtClean="0"/>
                        <a:t>bp</a:t>
                      </a:r>
                      <a:endParaRPr lang="de-DE" sz="900" b="1" dirty="0"/>
                    </a:p>
                  </p:txBody>
                </p:sp>
                <p:cxnSp>
                  <p:nvCxnSpPr>
                    <p:cNvPr id="280" name="Gerade Verbindung 279"/>
                    <p:cNvCxnSpPr/>
                    <p:nvPr/>
                  </p:nvCxnSpPr>
                  <p:spPr>
                    <a:xfrm flipV="1">
                      <a:off x="1618774" y="7419954"/>
                      <a:ext cx="103663" cy="51175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1" name="Gerade Verbindung 280"/>
                    <p:cNvCxnSpPr/>
                    <p:nvPr/>
                  </p:nvCxnSpPr>
                  <p:spPr>
                    <a:xfrm>
                      <a:off x="1618774" y="7599517"/>
                      <a:ext cx="103663" cy="63328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75" name="Rechteck 274"/>
                  <p:cNvSpPr/>
                  <p:nvPr/>
                </p:nvSpPr>
                <p:spPr>
                  <a:xfrm>
                    <a:off x="1261094" y="5419026"/>
                    <a:ext cx="263214" cy="24984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en-US" sz="1200" b="1" u="none" strike="noStrike" dirty="0" smtClean="0">
                        <a:effectLst/>
                      </a:rPr>
                      <a:t>3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76" name="Rechteck 275"/>
                  <p:cNvSpPr/>
                  <p:nvPr/>
                </p:nvSpPr>
                <p:spPr>
                  <a:xfrm>
                    <a:off x="753364" y="5419026"/>
                    <a:ext cx="263214" cy="24984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/>
                      <a:t>1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77" name="Rechteck 276"/>
                  <p:cNvSpPr/>
                  <p:nvPr/>
                </p:nvSpPr>
                <p:spPr>
                  <a:xfrm>
                    <a:off x="1007229" y="5419026"/>
                    <a:ext cx="26321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>
                        <a:solidFill>
                          <a:srgbClr val="FF0000"/>
                        </a:solidFill>
                      </a:rPr>
                      <a:t>2</a:t>
                    </a:r>
                    <a:endParaRPr lang="en-US" sz="1200" b="1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273" name="Rechteck 272"/>
                  <p:cNvSpPr/>
                  <p:nvPr/>
                </p:nvSpPr>
                <p:spPr>
                  <a:xfrm>
                    <a:off x="443395" y="5419026"/>
                    <a:ext cx="31931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 smtClean="0"/>
                      <a:t>M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74" name="Rechteck 273"/>
                  <p:cNvSpPr/>
                  <p:nvPr/>
                </p:nvSpPr>
                <p:spPr>
                  <a:xfrm>
                    <a:off x="1514958" y="5419026"/>
                    <a:ext cx="31931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 smtClean="0"/>
                      <a:t>M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69" name="Rechteck 268"/>
                  <p:cNvSpPr/>
                  <p:nvPr/>
                </p:nvSpPr>
                <p:spPr>
                  <a:xfrm>
                    <a:off x="1277933" y="7081148"/>
                    <a:ext cx="263214" cy="24984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en-US" sz="1200" b="1" u="none" strike="noStrike" dirty="0" smtClean="0">
                        <a:effectLst/>
                      </a:rPr>
                      <a:t>3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70" name="Rechteck 269"/>
                  <p:cNvSpPr/>
                  <p:nvPr/>
                </p:nvSpPr>
                <p:spPr>
                  <a:xfrm>
                    <a:off x="736208" y="7081148"/>
                    <a:ext cx="263214" cy="24984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/>
                      <a:t>1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71" name="Rechteck 270"/>
                  <p:cNvSpPr/>
                  <p:nvPr/>
                </p:nvSpPr>
                <p:spPr>
                  <a:xfrm>
                    <a:off x="1007070" y="7081148"/>
                    <a:ext cx="26321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>
                        <a:solidFill>
                          <a:srgbClr val="FF0000"/>
                        </a:solidFill>
                      </a:rPr>
                      <a:t>2</a:t>
                    </a:r>
                    <a:endParaRPr lang="en-US" sz="1200" b="1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267" name="Rechteck 266"/>
                  <p:cNvSpPr/>
                  <p:nvPr/>
                </p:nvSpPr>
                <p:spPr>
                  <a:xfrm>
                    <a:off x="438630" y="7081148"/>
                    <a:ext cx="31931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 smtClean="0"/>
                      <a:t>M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</p:grpSp>
          </p:grpSp>
          <p:grpSp>
            <p:nvGrpSpPr>
              <p:cNvPr id="87" name="Gruppieren 86"/>
              <p:cNvGrpSpPr/>
              <p:nvPr/>
            </p:nvGrpSpPr>
            <p:grpSpPr>
              <a:xfrm>
                <a:off x="2652442" y="4683123"/>
                <a:ext cx="1969382" cy="3117852"/>
                <a:chOff x="2652442" y="4683123"/>
                <a:chExt cx="1969382" cy="3117852"/>
              </a:xfrm>
            </p:grpSpPr>
            <p:grpSp>
              <p:nvGrpSpPr>
                <p:cNvPr id="223" name="Gruppieren 222"/>
                <p:cNvGrpSpPr/>
                <p:nvPr/>
              </p:nvGrpSpPr>
              <p:grpSpPr>
                <a:xfrm>
                  <a:off x="2744469" y="4683123"/>
                  <a:ext cx="1186223" cy="680740"/>
                  <a:chOff x="837714" y="215898"/>
                  <a:chExt cx="1186223" cy="680740"/>
                </a:xfrm>
              </p:grpSpPr>
              <p:sp>
                <p:nvSpPr>
                  <p:cNvPr id="224" name="Textfeld 223"/>
                  <p:cNvSpPr txBox="1"/>
                  <p:nvPr/>
                </p:nvSpPr>
                <p:spPr>
                  <a:xfrm>
                    <a:off x="1114581" y="215898"/>
                    <a:ext cx="632481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de-DE" sz="1400" b="1" dirty="0" err="1" smtClean="0"/>
                      <a:t>RepW</a:t>
                    </a:r>
                    <a:endParaRPr lang="de-DE" sz="1400" b="1" dirty="0" smtClean="0"/>
                  </a:p>
                </p:txBody>
              </p:sp>
              <p:sp>
                <p:nvSpPr>
                  <p:cNvPr id="225" name="Textfeld 224"/>
                  <p:cNvSpPr txBox="1"/>
                  <p:nvPr/>
                </p:nvSpPr>
                <p:spPr>
                  <a:xfrm>
                    <a:off x="837714" y="434973"/>
                    <a:ext cx="1186223" cy="4616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de-DE" sz="1200" i="1" dirty="0" err="1" smtClean="0"/>
                      <a:t>Sulfitobacter</a:t>
                    </a:r>
                    <a:r>
                      <a:rPr lang="de-DE" sz="1200" i="1" dirty="0" smtClean="0"/>
                      <a:t> </a:t>
                    </a:r>
                    <a:r>
                      <a:rPr lang="de-DE" sz="1200" dirty="0" err="1" smtClean="0"/>
                      <a:t>sp</a:t>
                    </a:r>
                    <a:r>
                      <a:rPr lang="de-DE" sz="1200" dirty="0" smtClean="0"/>
                      <a:t>.</a:t>
                    </a:r>
                    <a:endParaRPr lang="de-DE" sz="1200" dirty="0"/>
                  </a:p>
                  <a:p>
                    <a:pPr algn="ctr"/>
                    <a:r>
                      <a:rPr lang="de-DE" sz="1200" dirty="0" smtClean="0"/>
                      <a:t>DSM 110093</a:t>
                    </a:r>
                  </a:p>
                </p:txBody>
              </p:sp>
            </p:grpSp>
            <p:grpSp>
              <p:nvGrpSpPr>
                <p:cNvPr id="52" name="Gruppieren 51"/>
                <p:cNvGrpSpPr/>
                <p:nvPr/>
              </p:nvGrpSpPr>
              <p:grpSpPr>
                <a:xfrm>
                  <a:off x="2657207" y="5419026"/>
                  <a:ext cx="1964617" cy="1334199"/>
                  <a:chOff x="2672245" y="5419026"/>
                  <a:chExt cx="1964617" cy="1334199"/>
                </a:xfrm>
              </p:grpSpPr>
              <p:pic>
                <p:nvPicPr>
                  <p:cNvPr id="288" name="Picture 3" descr="N:\dept\AG-Roseobacter\Vicky\Gelelektrophorese\2021\01 Jan\2021-01-19_D,E RV und C,D,E PCR 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8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2834" t="46332" r="57750" b="34728"/>
                  <a:stretch/>
                </p:blipFill>
                <p:spPr bwMode="auto">
                  <a:xfrm>
                    <a:off x="2691830" y="5467350"/>
                    <a:ext cx="1318195" cy="1285875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cxnSp>
                <p:nvCxnSpPr>
                  <p:cNvPr id="293" name="Gerade Verbindung 292"/>
                  <p:cNvCxnSpPr/>
                  <p:nvPr/>
                </p:nvCxnSpPr>
                <p:spPr>
                  <a:xfrm>
                    <a:off x="4015895" y="6094795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4" name="Gerade Verbindung 293"/>
                  <p:cNvCxnSpPr/>
                  <p:nvPr/>
                </p:nvCxnSpPr>
                <p:spPr>
                  <a:xfrm>
                    <a:off x="4015895" y="5899732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5" name="Gerade Verbindung 294"/>
                  <p:cNvCxnSpPr/>
                  <p:nvPr/>
                </p:nvCxnSpPr>
                <p:spPr>
                  <a:xfrm>
                    <a:off x="4020658" y="633748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96" name="Textfeld 295"/>
                  <p:cNvSpPr txBox="1"/>
                  <p:nvPr/>
                </p:nvSpPr>
                <p:spPr>
                  <a:xfrm>
                    <a:off x="4070681" y="5789616"/>
                    <a:ext cx="56618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900" b="1" dirty="0" smtClean="0"/>
                      <a:t>4000 </a:t>
                    </a:r>
                    <a:r>
                      <a:rPr lang="de-DE" sz="900" b="1" dirty="0" err="1" smtClean="0"/>
                      <a:t>bp</a:t>
                    </a:r>
                    <a:endParaRPr lang="de-DE" sz="900" b="1" dirty="0"/>
                  </a:p>
                </p:txBody>
              </p:sp>
              <p:sp>
                <p:nvSpPr>
                  <p:cNvPr id="297" name="Textfeld 296"/>
                  <p:cNvSpPr txBox="1"/>
                  <p:nvPr/>
                </p:nvSpPr>
                <p:spPr>
                  <a:xfrm>
                    <a:off x="4070681" y="5983188"/>
                    <a:ext cx="56618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900" b="1" dirty="0" smtClean="0"/>
                      <a:t>2000 </a:t>
                    </a:r>
                    <a:r>
                      <a:rPr lang="de-DE" sz="900" b="1" dirty="0" err="1" smtClean="0"/>
                      <a:t>bp</a:t>
                    </a:r>
                    <a:endParaRPr lang="de-DE" sz="900" b="1" dirty="0"/>
                  </a:p>
                </p:txBody>
              </p:sp>
              <p:sp>
                <p:nvSpPr>
                  <p:cNvPr id="298" name="Textfeld 297"/>
                  <p:cNvSpPr txBox="1"/>
                  <p:nvPr/>
                </p:nvSpPr>
                <p:spPr>
                  <a:xfrm>
                    <a:off x="4070681" y="6229021"/>
                    <a:ext cx="56618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900" b="1" dirty="0" smtClean="0"/>
                      <a:t>1000 </a:t>
                    </a:r>
                    <a:r>
                      <a:rPr lang="de-DE" sz="900" b="1" dirty="0" err="1" smtClean="0"/>
                      <a:t>bp</a:t>
                    </a:r>
                    <a:endParaRPr lang="de-DE" sz="900" b="1" dirty="0"/>
                  </a:p>
                </p:txBody>
              </p:sp>
              <p:sp>
                <p:nvSpPr>
                  <p:cNvPr id="304" name="Rechteck 303"/>
                  <p:cNvSpPr/>
                  <p:nvPr/>
                </p:nvSpPr>
                <p:spPr>
                  <a:xfrm>
                    <a:off x="3489944" y="5419026"/>
                    <a:ext cx="263214" cy="24984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en-US" sz="1200" b="1" u="none" strike="noStrike" dirty="0" smtClean="0">
                        <a:effectLst/>
                      </a:rPr>
                      <a:t>3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305" name="Rechteck 304"/>
                  <p:cNvSpPr/>
                  <p:nvPr/>
                </p:nvSpPr>
                <p:spPr>
                  <a:xfrm>
                    <a:off x="2982214" y="5419026"/>
                    <a:ext cx="263214" cy="24984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/>
                      <a:t>1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306" name="Rechteck 305"/>
                  <p:cNvSpPr/>
                  <p:nvPr/>
                </p:nvSpPr>
                <p:spPr>
                  <a:xfrm>
                    <a:off x="3236079" y="5419026"/>
                    <a:ext cx="26321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>
                        <a:solidFill>
                          <a:srgbClr val="FF0000"/>
                        </a:solidFill>
                      </a:rPr>
                      <a:t>2</a:t>
                    </a:r>
                    <a:endParaRPr lang="en-US" sz="1200" b="1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307" name="Rechteck 306"/>
                  <p:cNvSpPr/>
                  <p:nvPr/>
                </p:nvSpPr>
                <p:spPr>
                  <a:xfrm>
                    <a:off x="2672245" y="5419026"/>
                    <a:ext cx="31931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 smtClean="0"/>
                      <a:t>M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308" name="Rechteck 307"/>
                  <p:cNvSpPr/>
                  <p:nvPr/>
                </p:nvSpPr>
                <p:spPr>
                  <a:xfrm>
                    <a:off x="3743808" y="5419026"/>
                    <a:ext cx="31931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 smtClean="0"/>
                      <a:t>M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</p:grpSp>
            <p:grpSp>
              <p:nvGrpSpPr>
                <p:cNvPr id="81" name="Gruppieren 80"/>
                <p:cNvGrpSpPr/>
                <p:nvPr/>
              </p:nvGrpSpPr>
              <p:grpSpPr>
                <a:xfrm>
                  <a:off x="2652442" y="7081148"/>
                  <a:ext cx="1836032" cy="719827"/>
                  <a:chOff x="2652442" y="7081148"/>
                  <a:chExt cx="1836032" cy="719827"/>
                </a:xfrm>
              </p:grpSpPr>
              <p:pic>
                <p:nvPicPr>
                  <p:cNvPr id="289" name="Picture 3" descr="N:\dept\AG-Roseobacter\Vicky\Gelelektrophorese\2021\01 Jan\2021-01-19_D,E RV und C,D,E PCR .pn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8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2737" t="51766" r="10760" b="41869"/>
                  <a:stretch/>
                </p:blipFill>
                <p:spPr bwMode="auto">
                  <a:xfrm>
                    <a:off x="2682918" y="7353299"/>
                    <a:ext cx="1160614" cy="447676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300" name="Textfeld 299"/>
                  <p:cNvSpPr txBox="1"/>
                  <p:nvPr/>
                </p:nvSpPr>
                <p:spPr>
                  <a:xfrm>
                    <a:off x="3922293" y="7545261"/>
                    <a:ext cx="56618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900" b="1" dirty="0" smtClean="0"/>
                      <a:t>2000 </a:t>
                    </a:r>
                    <a:r>
                      <a:rPr lang="de-DE" sz="900" b="1" dirty="0" err="1" smtClean="0"/>
                      <a:t>bp</a:t>
                    </a:r>
                    <a:endParaRPr lang="de-DE" sz="900" b="1" dirty="0"/>
                  </a:p>
                </p:txBody>
              </p:sp>
              <p:sp>
                <p:nvSpPr>
                  <p:cNvPr id="301" name="Textfeld 300"/>
                  <p:cNvSpPr txBox="1"/>
                  <p:nvPr/>
                </p:nvSpPr>
                <p:spPr>
                  <a:xfrm>
                    <a:off x="3922293" y="7305311"/>
                    <a:ext cx="56618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900" b="1" dirty="0" smtClean="0"/>
                      <a:t>3000 </a:t>
                    </a:r>
                    <a:r>
                      <a:rPr lang="de-DE" sz="900" b="1" dirty="0" err="1" smtClean="0"/>
                      <a:t>bp</a:t>
                    </a:r>
                    <a:endParaRPr lang="de-DE" sz="900" b="1" dirty="0"/>
                  </a:p>
                </p:txBody>
              </p:sp>
              <p:cxnSp>
                <p:nvCxnSpPr>
                  <p:cNvPr id="302" name="Gerade Verbindung 301"/>
                  <p:cNvCxnSpPr/>
                  <p:nvPr/>
                </p:nvCxnSpPr>
                <p:spPr>
                  <a:xfrm flipV="1">
                    <a:off x="3861161" y="7419954"/>
                    <a:ext cx="103663" cy="51175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3" name="Gerade Verbindung 302"/>
                  <p:cNvCxnSpPr/>
                  <p:nvPr/>
                </p:nvCxnSpPr>
                <p:spPr>
                  <a:xfrm>
                    <a:off x="3861161" y="7599517"/>
                    <a:ext cx="103663" cy="6332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09" name="Rechteck 308"/>
                  <p:cNvSpPr/>
                  <p:nvPr/>
                </p:nvSpPr>
                <p:spPr>
                  <a:xfrm>
                    <a:off x="3491745" y="7081148"/>
                    <a:ext cx="263214" cy="24984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en-US" sz="1200" b="1" u="none" strike="noStrike" dirty="0" smtClean="0">
                        <a:effectLst/>
                      </a:rPr>
                      <a:t>3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310" name="Rechteck 309"/>
                  <p:cNvSpPr/>
                  <p:nvPr/>
                </p:nvSpPr>
                <p:spPr>
                  <a:xfrm>
                    <a:off x="2950020" y="7081148"/>
                    <a:ext cx="263214" cy="24984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/>
                      <a:t>1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311" name="Rechteck 310"/>
                  <p:cNvSpPr/>
                  <p:nvPr/>
                </p:nvSpPr>
                <p:spPr>
                  <a:xfrm>
                    <a:off x="3220882" y="7081148"/>
                    <a:ext cx="26321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>
                        <a:solidFill>
                          <a:srgbClr val="FF0000"/>
                        </a:solidFill>
                      </a:rPr>
                      <a:t>2</a:t>
                    </a:r>
                    <a:endParaRPr lang="en-US" sz="1200" b="1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312" name="Rechteck 311"/>
                  <p:cNvSpPr/>
                  <p:nvPr/>
                </p:nvSpPr>
                <p:spPr>
                  <a:xfrm>
                    <a:off x="2652442" y="7081148"/>
                    <a:ext cx="31931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fontAlgn="ctr"/>
                    <a:r>
                      <a:rPr lang="de-DE" sz="1200" b="1" dirty="0" smtClean="0"/>
                      <a:t>M</a:t>
                    </a:r>
                    <a:endParaRPr lang="en-US" sz="1200" b="1" i="1" dirty="0">
                      <a:solidFill>
                        <a:srgbClr val="000000"/>
                      </a:solidFill>
                    </a:endParaRPr>
                  </a:p>
                </p:txBody>
              </p:sp>
            </p:grpSp>
          </p:grpSp>
        </p:grpSp>
      </p:grpSp>
    </p:spTree>
    <p:extLst>
      <p:ext uri="{BB962C8B-B14F-4D97-AF65-F5344CB8AC3E}">
        <p14:creationId xmlns:p14="http://schemas.microsoft.com/office/powerpoint/2010/main" val="39337746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7</Words>
  <Application>Microsoft Office PowerPoint</Application>
  <PresentationFormat>Bildschirmpräsentation (4:3)</PresentationFormat>
  <Paragraphs>97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etersen, Joern</dc:creator>
  <cp:lastModifiedBy>Petersen, Joern</cp:lastModifiedBy>
  <cp:revision>273</cp:revision>
  <cp:lastPrinted>2022-02-28T12:30:49Z</cp:lastPrinted>
  <dcterms:created xsi:type="dcterms:W3CDTF">2016-08-31T11:16:16Z</dcterms:created>
  <dcterms:modified xsi:type="dcterms:W3CDTF">2022-02-28T13:13:42Z</dcterms:modified>
</cp:coreProperties>
</file>